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19B8D-B2BA-4E9A-BAAE-AA80EABCB3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31815-14C0-4B93-A3DB-27B0A11946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6067EB-95E1-4E85-A689-987D21C1A2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C85B0-346E-4DAC-85D4-75E1610BC1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6DAAA0-60E0-4E18-BF57-264B1EB838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DD6C34-1C38-412C-861E-7219FDA3A3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E7237-69E9-40A1-BC15-3860628982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FFB74-74C3-41A8-B3BC-975D33667E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631BDA-DAAF-4E6F-BC37-97228DC235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2E5C9-6379-40C0-9F05-162CD86043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59A3C8-4B52-45B5-A481-F3851C6953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A8404-41F6-408F-A0D0-5C5CA39CC4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FB91AD-3E6E-4FC1-BA1A-693D6BF072EC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95720" y="-1522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3195720" y="-1522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3138480" y="60480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3138480" y="22096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3138480" y="149544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138480" y="24382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3138480" y="76212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3138480" y="247680"/>
            <a:ext cx="9144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sp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9" name=""/>
          <p:cNvGrpSpPr/>
          <p:nvPr/>
        </p:nvGrpSpPr>
        <p:grpSpPr>
          <a:xfrm>
            <a:off x="38160" y="76320"/>
            <a:ext cx="2857320" cy="3771720"/>
            <a:chOff x="38160" y="76320"/>
            <a:chExt cx="2857320" cy="3771720"/>
          </a:xfrm>
        </p:grpSpPr>
        <p:sp>
          <p:nvSpPr>
            <p:cNvPr id="50" name=""/>
            <p:cNvSpPr/>
            <p:nvPr/>
          </p:nvSpPr>
          <p:spPr>
            <a:xfrm>
              <a:off x="228600" y="76320"/>
              <a:ext cx="990720" cy="304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80880" y="6858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80880" y="10666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80880" y="14479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08000" y="3618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14480" y="5652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.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82440" y="958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5.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88920" y="16509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39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82440" y="20192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53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76320" y="27432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77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60" name=""/>
            <p:cNvGrpSpPr/>
            <p:nvPr/>
          </p:nvGrpSpPr>
          <p:grpSpPr>
            <a:xfrm>
              <a:off x="380880" y="457200"/>
              <a:ext cx="228600" cy="3276360"/>
              <a:chOff x="380880" y="457200"/>
              <a:chExt cx="228600" cy="3276360"/>
            </a:xfrm>
          </p:grpSpPr>
          <p:grpSp>
            <p:nvGrpSpPr>
              <p:cNvPr id="61" name=""/>
              <p:cNvGrpSpPr/>
              <p:nvPr/>
            </p:nvGrpSpPr>
            <p:grpSpPr>
              <a:xfrm>
                <a:off x="380880" y="457200"/>
                <a:ext cx="228600" cy="3276000"/>
                <a:chOff x="380880" y="457200"/>
                <a:chExt cx="228600" cy="3276000"/>
              </a:xfrm>
            </p:grpSpPr>
            <p:sp>
              <p:nvSpPr>
                <p:cNvPr id="62" name=""/>
                <p:cNvSpPr/>
                <p:nvPr/>
              </p:nvSpPr>
              <p:spPr>
                <a:xfrm>
                  <a:off x="457200" y="459000"/>
                  <a:ext cx="76320" cy="32742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380880" y="45720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64" name=""/>
              <p:cNvSpPr/>
              <p:nvPr/>
            </p:nvSpPr>
            <p:spPr>
              <a:xfrm>
                <a:off x="380880" y="373356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65" name=""/>
            <p:cNvSpPr/>
            <p:nvPr/>
          </p:nvSpPr>
          <p:spPr>
            <a:xfrm>
              <a:off x="88920" y="13460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27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80880" y="17524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80880" y="21337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88920" y="17971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4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82440" y="22478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60.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69840" y="24066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65.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84280" y="349200"/>
              <a:ext cx="6858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G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84280" y="571680"/>
              <a:ext cx="6858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T02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96880" y="92088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A02TA, ASAA02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80880" y="12193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88920" y="11113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9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96880" y="110484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A01TG, AJAG02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609480" y="1308240"/>
              <a:ext cx="16002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GT01TG, AJAA01TA, ASCA01C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09480" y="1600200"/>
              <a:ext cx="15242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1TC, ASCT02CT, AJCT03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80880" y="19051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609480" y="1752480"/>
              <a:ext cx="15242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T02AT, AJCA02CA, AJGA02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609480" y="2057400"/>
              <a:ext cx="19051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C01GA, AJAC05AT, ASAC02AG, AJCG02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0880" y="23623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03360" y="2254320"/>
              <a:ext cx="8445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C02G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80880" y="25146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609480" y="2413080"/>
              <a:ext cx="15242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C01TT, AJCC04AA, ASCC02C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80880" y="26668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76320" y="25909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72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609480" y="2590920"/>
              <a:ext cx="2286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1GT, ASTT04CA, AJGA01GA, AJGT03TA, ASTT01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80880" y="28195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609480" y="2743200"/>
              <a:ext cx="2286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A03TA, AJAC01TT, AJAG02AT, AJGA01AT, AJGT01AA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80880" y="29718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6320" y="28954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1.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609480" y="2895480"/>
              <a:ext cx="8445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A04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80880" y="32767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82440" y="31496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96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603360" y="3162240"/>
              <a:ext cx="8445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G04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380880" y="3429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8160" y="33210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00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609480" y="3327480"/>
              <a:ext cx="10670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GT04AA, AJCA05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8160" y="36194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12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615960" y="3619440"/>
              <a:ext cx="16765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A03AC, AJTA04TA, AJAT05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02" name=""/>
          <p:cNvSpPr/>
          <p:nvPr/>
        </p:nvSpPr>
        <p:spPr>
          <a:xfrm>
            <a:off x="3276720" y="0"/>
            <a:ext cx="99036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roup 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03" name=""/>
          <p:cNvGrpSpPr/>
          <p:nvPr/>
        </p:nvGrpSpPr>
        <p:grpSpPr>
          <a:xfrm>
            <a:off x="3048120" y="304920"/>
            <a:ext cx="2977920" cy="2825280"/>
            <a:chOff x="3048120" y="304920"/>
            <a:chExt cx="2977920" cy="2825280"/>
          </a:xfrm>
        </p:grpSpPr>
        <p:sp>
          <p:nvSpPr>
            <p:cNvPr id="104" name=""/>
            <p:cNvSpPr/>
            <p:nvPr/>
          </p:nvSpPr>
          <p:spPr>
            <a:xfrm>
              <a:off x="3390840" y="711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397320" y="15555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079800" y="3301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048120" y="5842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0.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3092400" y="16063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0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3098880" y="21207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59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3079800" y="26794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76.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11" name=""/>
            <p:cNvGrpSpPr/>
            <p:nvPr/>
          </p:nvGrpSpPr>
          <p:grpSpPr>
            <a:xfrm>
              <a:off x="3384720" y="412560"/>
              <a:ext cx="228600" cy="2590200"/>
              <a:chOff x="3384720" y="412560"/>
              <a:chExt cx="228600" cy="2590200"/>
            </a:xfrm>
          </p:grpSpPr>
          <p:grpSp>
            <p:nvGrpSpPr>
              <p:cNvPr id="112" name=""/>
              <p:cNvGrpSpPr/>
              <p:nvPr/>
            </p:nvGrpSpPr>
            <p:grpSpPr>
              <a:xfrm>
                <a:off x="3384720" y="412560"/>
                <a:ext cx="228600" cy="2589840"/>
                <a:chOff x="3384720" y="412560"/>
                <a:chExt cx="228600" cy="2589840"/>
              </a:xfrm>
            </p:grpSpPr>
            <p:sp>
              <p:nvSpPr>
                <p:cNvPr id="113" name=""/>
                <p:cNvSpPr/>
                <p:nvPr/>
              </p:nvSpPr>
              <p:spPr>
                <a:xfrm>
                  <a:off x="3461040" y="414000"/>
                  <a:ext cx="76320" cy="25884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3384720" y="41256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15" name=""/>
              <p:cNvSpPr/>
              <p:nvPr/>
            </p:nvSpPr>
            <p:spPr>
              <a:xfrm>
                <a:off x="3384720" y="300276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16" name=""/>
            <p:cNvSpPr/>
            <p:nvPr/>
          </p:nvSpPr>
          <p:spPr>
            <a:xfrm>
              <a:off x="3092400" y="14349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36.9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3384720" y="17082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384720" y="22413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085920" y="18349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9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085920" y="24192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68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651120" y="304920"/>
              <a:ext cx="158760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A03GT, AJAA02TT, ASTA01C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3651120" y="565200"/>
              <a:ext cx="68580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A01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384720" y="11746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092400" y="1066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25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638520" y="1041480"/>
              <a:ext cx="114300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A02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3632040" y="1441440"/>
              <a:ext cx="152424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GA01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3384720" y="19368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625920" y="1568520"/>
              <a:ext cx="240012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C01AT, AJTT07AA, ASAA03CT, AJAC01AG, ASAT11AA,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A02TA, ASAG02AT, ASTT06AA, ASCA02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3632040" y="2127240"/>
              <a:ext cx="139068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A05AA, ASAA04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3390840" y="25207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625920" y="2406600"/>
              <a:ext cx="152388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T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3384720" y="27748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3575160" y="2622600"/>
              <a:ext cx="228600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T02CT, AJAA02AA, ASAA02AA, ASAA03AG, ASGT07AT, ASAT02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625920" y="1822320"/>
              <a:ext cx="152388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1A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3085920" y="28893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0.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3581280" y="2901960"/>
              <a:ext cx="609840" cy="2282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G01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37" name=""/>
          <p:cNvGrpSpPr/>
          <p:nvPr/>
        </p:nvGrpSpPr>
        <p:grpSpPr>
          <a:xfrm>
            <a:off x="6130800" y="0"/>
            <a:ext cx="3013200" cy="1415880"/>
            <a:chOff x="6130800" y="0"/>
            <a:chExt cx="3013200" cy="1415880"/>
          </a:xfrm>
        </p:grpSpPr>
        <p:sp>
          <p:nvSpPr>
            <p:cNvPr id="138" name=""/>
            <p:cNvSpPr/>
            <p:nvPr/>
          </p:nvSpPr>
          <p:spPr>
            <a:xfrm>
              <a:off x="6429240" y="660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6156360" y="3780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6156360" y="5587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41" name=""/>
            <p:cNvGrpSpPr/>
            <p:nvPr/>
          </p:nvGrpSpPr>
          <p:grpSpPr>
            <a:xfrm>
              <a:off x="6429240" y="457200"/>
              <a:ext cx="228600" cy="838080"/>
              <a:chOff x="6429240" y="457200"/>
              <a:chExt cx="228600" cy="838080"/>
            </a:xfrm>
          </p:grpSpPr>
          <p:grpSp>
            <p:nvGrpSpPr>
              <p:cNvPr id="142" name=""/>
              <p:cNvGrpSpPr/>
              <p:nvPr/>
            </p:nvGrpSpPr>
            <p:grpSpPr>
              <a:xfrm>
                <a:off x="6429240" y="457200"/>
                <a:ext cx="228600" cy="838080"/>
                <a:chOff x="6429240" y="457200"/>
                <a:chExt cx="228600" cy="838080"/>
              </a:xfrm>
            </p:grpSpPr>
            <p:sp>
              <p:nvSpPr>
                <p:cNvPr id="143" name=""/>
                <p:cNvSpPr/>
                <p:nvPr/>
              </p:nvSpPr>
              <p:spPr>
                <a:xfrm>
                  <a:off x="6505560" y="457560"/>
                  <a:ext cx="76320" cy="83772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6429240" y="45720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45" name=""/>
              <p:cNvSpPr/>
              <p:nvPr/>
            </p:nvSpPr>
            <p:spPr>
              <a:xfrm>
                <a:off x="6429240" y="129528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46" name=""/>
            <p:cNvSpPr/>
            <p:nvPr/>
          </p:nvSpPr>
          <p:spPr>
            <a:xfrm>
              <a:off x="6699240" y="333360"/>
              <a:ext cx="24447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G01GA, ASGA01GA, ASGT02AG, AJGA01CT,  AJGA01TG,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GA01TA, ASAC01TT, AJTT01TG, ASCA01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6130800" y="10224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9.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6689520" y="1022400"/>
              <a:ext cx="2286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G01AT, AJAG01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6137280" y="11872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23.7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6689520" y="1187280"/>
              <a:ext cx="10922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A01TA, ASAT06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6352920" y="0"/>
              <a:ext cx="99072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6696000" y="558720"/>
              <a:ext cx="6094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A02AG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6429240" y="8380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6149880" y="7300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6696000" y="730080"/>
              <a:ext cx="10666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C05TA, AJAA02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6429240" y="1143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57" name=""/>
          <p:cNvGrpSpPr/>
          <p:nvPr/>
        </p:nvGrpSpPr>
        <p:grpSpPr>
          <a:xfrm>
            <a:off x="6127920" y="1676520"/>
            <a:ext cx="3016080" cy="1266840"/>
            <a:chOff x="6127920" y="1676520"/>
            <a:chExt cx="3016080" cy="1266840"/>
          </a:xfrm>
        </p:grpSpPr>
        <p:sp>
          <p:nvSpPr>
            <p:cNvPr id="158" name=""/>
            <p:cNvSpPr/>
            <p:nvPr/>
          </p:nvSpPr>
          <p:spPr>
            <a:xfrm>
              <a:off x="6429240" y="23367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6156360" y="20545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6156360" y="22352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61" name=""/>
            <p:cNvGrpSpPr/>
            <p:nvPr/>
          </p:nvGrpSpPr>
          <p:grpSpPr>
            <a:xfrm>
              <a:off x="6429240" y="2133720"/>
              <a:ext cx="228600" cy="685800"/>
              <a:chOff x="6429240" y="2133720"/>
              <a:chExt cx="228600" cy="685800"/>
            </a:xfrm>
          </p:grpSpPr>
          <p:grpSp>
            <p:nvGrpSpPr>
              <p:cNvPr id="162" name=""/>
              <p:cNvGrpSpPr/>
              <p:nvPr/>
            </p:nvGrpSpPr>
            <p:grpSpPr>
              <a:xfrm>
                <a:off x="6429240" y="2133720"/>
                <a:ext cx="228600" cy="685800"/>
                <a:chOff x="6429240" y="2133720"/>
                <a:chExt cx="228600" cy="685800"/>
              </a:xfrm>
            </p:grpSpPr>
            <p:sp>
              <p:nvSpPr>
                <p:cNvPr id="163" name=""/>
                <p:cNvSpPr/>
                <p:nvPr/>
              </p:nvSpPr>
              <p:spPr>
                <a:xfrm>
                  <a:off x="6505560" y="2134080"/>
                  <a:ext cx="76320" cy="68544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6429240" y="213372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65" name=""/>
              <p:cNvSpPr/>
              <p:nvPr/>
            </p:nvSpPr>
            <p:spPr>
              <a:xfrm>
                <a:off x="6429240" y="281952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66" name=""/>
            <p:cNvSpPr/>
            <p:nvPr/>
          </p:nvSpPr>
          <p:spPr>
            <a:xfrm>
              <a:off x="6699240" y="2009880"/>
              <a:ext cx="24447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A03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6130800" y="25750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1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6696000" y="2581560"/>
              <a:ext cx="12193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T01TT, AJAT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6127920" y="27241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5.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6705720" y="2714760"/>
              <a:ext cx="10922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T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6353280" y="1676520"/>
              <a:ext cx="99036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14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6696000" y="2235240"/>
              <a:ext cx="22957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G01TT, ASCG02AT, AJTG02CT, ASTA02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6429240" y="25146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6149880" y="24066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6696000" y="2406600"/>
              <a:ext cx="10670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6438960" y="26672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77" name=""/>
          <p:cNvSpPr/>
          <p:nvPr/>
        </p:nvSpPr>
        <p:spPr>
          <a:xfrm>
            <a:off x="95400" y="580392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36.0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95400" y="565776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32.1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88920" y="531504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23.7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76320" y="501012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12.4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88920" y="546084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27.9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2" name=""/>
          <p:cNvGrpSpPr/>
          <p:nvPr/>
        </p:nvGrpSpPr>
        <p:grpSpPr>
          <a:xfrm>
            <a:off x="108000" y="4356000"/>
            <a:ext cx="2946240" cy="2025720"/>
            <a:chOff x="108000" y="4356000"/>
            <a:chExt cx="2946240" cy="2025720"/>
          </a:xfrm>
        </p:grpSpPr>
        <p:sp>
          <p:nvSpPr>
            <p:cNvPr id="183" name=""/>
            <p:cNvSpPr/>
            <p:nvPr/>
          </p:nvSpPr>
          <p:spPr>
            <a:xfrm>
              <a:off x="387360" y="48895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387360" y="57657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08000" y="46353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08000" y="47941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187" name=""/>
            <p:cNvGrpSpPr/>
            <p:nvPr/>
          </p:nvGrpSpPr>
          <p:grpSpPr>
            <a:xfrm>
              <a:off x="387360" y="4737240"/>
              <a:ext cx="228600" cy="1523880"/>
              <a:chOff x="387360" y="4737240"/>
              <a:chExt cx="228600" cy="1523880"/>
            </a:xfrm>
          </p:grpSpPr>
          <p:grpSp>
            <p:nvGrpSpPr>
              <p:cNvPr id="188" name=""/>
              <p:cNvGrpSpPr/>
              <p:nvPr/>
            </p:nvGrpSpPr>
            <p:grpSpPr>
              <a:xfrm>
                <a:off x="387360" y="4737240"/>
                <a:ext cx="228600" cy="1523520"/>
                <a:chOff x="387360" y="4737240"/>
                <a:chExt cx="228600" cy="1523520"/>
              </a:xfrm>
            </p:grpSpPr>
            <p:sp>
              <p:nvSpPr>
                <p:cNvPr id="189" name=""/>
                <p:cNvSpPr/>
                <p:nvPr/>
              </p:nvSpPr>
              <p:spPr>
                <a:xfrm>
                  <a:off x="463680" y="4737960"/>
                  <a:ext cx="76320" cy="152280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>
                  <a:off x="387360" y="473724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191" name=""/>
              <p:cNvSpPr/>
              <p:nvPr/>
            </p:nvSpPr>
            <p:spPr>
              <a:xfrm>
                <a:off x="387360" y="626112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92" name=""/>
            <p:cNvSpPr/>
            <p:nvPr/>
          </p:nvSpPr>
          <p:spPr>
            <a:xfrm>
              <a:off x="399960" y="58928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660240" y="4629240"/>
              <a:ext cx="19051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G01CA, AJAG02TA, ASAT02G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615960" y="5315040"/>
              <a:ext cx="24382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C04TA, ASAC01GA, AJGA01AG, ASGA01AG, ASAT09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387360" y="51181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660240" y="478800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2G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609480" y="5454720"/>
              <a:ext cx="23623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C04AA, AJAT03TT, AJGA01AC, ASGA03AC, AJAT04AT, ASAA01G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615960" y="5670720"/>
              <a:ext cx="7491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C05C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622440" y="6153120"/>
              <a:ext cx="15238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C03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235080" y="4356000"/>
              <a:ext cx="99036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12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47640" y="4997520"/>
              <a:ext cx="22478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T04TT, ASCC01AG, ASAT08AA, AJTG03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387360" y="54230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387360" y="55753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09480" y="5810400"/>
              <a:ext cx="23623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3CT, AJGA02AC, AJAG02AC, ASTA02TA, ASGA01AC, ASCC01TG, AJCC01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5" name=""/>
          <p:cNvSpPr/>
          <p:nvPr/>
        </p:nvSpPr>
        <p:spPr>
          <a:xfrm>
            <a:off x="88920" y="614664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48.8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6" name=""/>
          <p:cNvGrpSpPr/>
          <p:nvPr/>
        </p:nvGrpSpPr>
        <p:grpSpPr>
          <a:xfrm>
            <a:off x="3200400" y="3657600"/>
            <a:ext cx="3200400" cy="2854440"/>
            <a:chOff x="3200400" y="3657600"/>
            <a:chExt cx="3200400" cy="2854440"/>
          </a:xfrm>
        </p:grpSpPr>
        <p:sp>
          <p:nvSpPr>
            <p:cNvPr id="207" name=""/>
            <p:cNvSpPr/>
            <p:nvPr/>
          </p:nvSpPr>
          <p:spPr>
            <a:xfrm>
              <a:off x="3543480" y="42958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3552840" y="52578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3232080" y="40640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3228840" y="41911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3216240" y="53402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0.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3213000" y="5854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59.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13" name=""/>
            <p:cNvGrpSpPr/>
            <p:nvPr/>
          </p:nvGrpSpPr>
          <p:grpSpPr>
            <a:xfrm>
              <a:off x="3537000" y="4146480"/>
              <a:ext cx="228600" cy="2254320"/>
              <a:chOff x="3537000" y="4146480"/>
              <a:chExt cx="228600" cy="2254320"/>
            </a:xfrm>
          </p:grpSpPr>
          <p:grpSp>
            <p:nvGrpSpPr>
              <p:cNvPr id="214" name=""/>
              <p:cNvGrpSpPr/>
              <p:nvPr/>
            </p:nvGrpSpPr>
            <p:grpSpPr>
              <a:xfrm>
                <a:off x="3537000" y="4146480"/>
                <a:ext cx="228600" cy="2253960"/>
                <a:chOff x="3537000" y="4146480"/>
                <a:chExt cx="228600" cy="2253960"/>
              </a:xfrm>
            </p:grpSpPr>
            <p:sp>
              <p:nvSpPr>
                <p:cNvPr id="215" name=""/>
                <p:cNvSpPr/>
                <p:nvPr/>
              </p:nvSpPr>
              <p:spPr>
                <a:xfrm>
                  <a:off x="3613320" y="4147560"/>
                  <a:ext cx="76320" cy="22528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3537000" y="414648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217" name=""/>
              <p:cNvSpPr/>
              <p:nvPr/>
            </p:nvSpPr>
            <p:spPr>
              <a:xfrm>
                <a:off x="3537000" y="64008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18" name=""/>
            <p:cNvSpPr/>
            <p:nvPr/>
          </p:nvSpPr>
          <p:spPr>
            <a:xfrm>
              <a:off x="3216240" y="51688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32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3537000" y="54421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3537000" y="597528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3209760" y="55688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8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3803760" y="4038480"/>
              <a:ext cx="206352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G01TT, ASTG01TT, ASAT04AC, AJAT03A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3803760" y="4175280"/>
              <a:ext cx="25970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G01AG, ASTT01CT, AJCG02AA, AJCT02AA, ASCT02AA, AJCA04AT, AJTC01GT, AJTT01TA, AJCT01AT, AJCT02TT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3533760" y="45147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3209760" y="44197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2.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3809880" y="472428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A03TA, AJCA01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3813120" y="5156280"/>
              <a:ext cx="15238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A03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3537000" y="56707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3807000" y="5340240"/>
              <a:ext cx="102204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T01A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3803760" y="5851440"/>
              <a:ext cx="13906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T03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3807000" y="6283440"/>
              <a:ext cx="15238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T01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3807000" y="5575320"/>
              <a:ext cx="152388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1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209760" y="6286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72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3352680" y="3657600"/>
              <a:ext cx="990720" cy="304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16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3809880" y="441972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G01C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3543480" y="46674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3209760" y="45720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16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3809880" y="4572000"/>
              <a:ext cx="11430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G01C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533760" y="48290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209760" y="47149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20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3543480" y="49910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3200400" y="48769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24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3809880" y="4876920"/>
              <a:ext cx="114300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G04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44" name=""/>
          <p:cNvSpPr/>
          <p:nvPr/>
        </p:nvSpPr>
        <p:spPr>
          <a:xfrm>
            <a:off x="6172200" y="502596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43.9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5" name=""/>
          <p:cNvSpPr/>
          <p:nvPr/>
        </p:nvSpPr>
        <p:spPr>
          <a:xfrm>
            <a:off x="6172200" y="411480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13.0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6" name=""/>
          <p:cNvSpPr/>
          <p:nvPr/>
        </p:nvSpPr>
        <p:spPr>
          <a:xfrm>
            <a:off x="6172200" y="427680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16.9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7" name=""/>
          <p:cNvSpPr/>
          <p:nvPr/>
        </p:nvSpPr>
        <p:spPr>
          <a:xfrm>
            <a:off x="6172200" y="4495680"/>
            <a:ext cx="4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25.7</a:t>
            </a:r>
            <a:endParaRPr b="0" lang="en-US" sz="6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48" name=""/>
          <p:cNvGrpSpPr/>
          <p:nvPr/>
        </p:nvGrpSpPr>
        <p:grpSpPr>
          <a:xfrm>
            <a:off x="6181560" y="3276720"/>
            <a:ext cx="3191040" cy="3400200"/>
            <a:chOff x="6181560" y="3276720"/>
            <a:chExt cx="3191040" cy="3400200"/>
          </a:xfrm>
        </p:grpSpPr>
        <p:sp>
          <p:nvSpPr>
            <p:cNvPr id="249" name=""/>
            <p:cNvSpPr/>
            <p:nvPr/>
          </p:nvSpPr>
          <p:spPr>
            <a:xfrm>
              <a:off x="6515280" y="391464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6515280" y="4734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6203880" y="36831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0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6200640" y="38098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6188040" y="486396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39.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6181560" y="53816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55.3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255" name=""/>
            <p:cNvGrpSpPr/>
            <p:nvPr/>
          </p:nvGrpSpPr>
          <p:grpSpPr>
            <a:xfrm>
              <a:off x="6508800" y="3765600"/>
              <a:ext cx="228600" cy="2796840"/>
              <a:chOff x="6508800" y="3765600"/>
              <a:chExt cx="228600" cy="2796840"/>
            </a:xfrm>
          </p:grpSpPr>
          <p:grpSp>
            <p:nvGrpSpPr>
              <p:cNvPr id="256" name=""/>
              <p:cNvGrpSpPr/>
              <p:nvPr/>
            </p:nvGrpSpPr>
            <p:grpSpPr>
              <a:xfrm>
                <a:off x="6508800" y="3765600"/>
                <a:ext cx="228600" cy="2796480"/>
                <a:chOff x="6508800" y="3765600"/>
                <a:chExt cx="228600" cy="2796480"/>
              </a:xfrm>
            </p:grpSpPr>
            <p:sp>
              <p:nvSpPr>
                <p:cNvPr id="257" name=""/>
                <p:cNvSpPr/>
                <p:nvPr/>
              </p:nvSpPr>
              <p:spPr>
                <a:xfrm>
                  <a:off x="6585120" y="3767040"/>
                  <a:ext cx="76320" cy="279504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258" name=""/>
                <p:cNvSpPr/>
                <p:nvPr/>
              </p:nvSpPr>
              <p:spPr>
                <a:xfrm>
                  <a:off x="6508800" y="3765600"/>
                  <a:ext cx="228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sp>
            <p:nvSpPr>
              <p:cNvPr id="259" name=""/>
              <p:cNvSpPr/>
              <p:nvPr/>
            </p:nvSpPr>
            <p:spPr>
              <a:xfrm>
                <a:off x="6508800" y="656244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260" name=""/>
            <p:cNvSpPr/>
            <p:nvPr/>
          </p:nvSpPr>
          <p:spPr>
            <a:xfrm>
              <a:off x="6181560" y="46386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30.1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6508800" y="49752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6496200" y="54864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6775560" y="3657600"/>
              <a:ext cx="206352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C01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6775560" y="3794040"/>
              <a:ext cx="259704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GA02CA, AJAT03TA, AJCT01AG, ASTC02TC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6505560" y="40575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6200640" y="396252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6781680" y="4267080"/>
              <a:ext cx="20574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TT03TA, AJAT02GT, AJAA05AC, ASAA06A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6794640" y="4632480"/>
              <a:ext cx="15238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2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6508800" y="51084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6778800" y="4863960"/>
              <a:ext cx="102204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CA02T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6762600" y="5172120"/>
              <a:ext cx="13906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4A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6750000" y="5378400"/>
              <a:ext cx="15238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A02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6769080" y="4965840"/>
              <a:ext cx="235584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A01TG, AJCA01AT, ASCA02CT, ASAA03TC, ASAA01GC, AJAT01TG, ASAT02TG, ASAA01AG, AJTT05AA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6181560" y="584820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72.2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6305400" y="3276720"/>
              <a:ext cx="990720" cy="3045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Group 2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6772320" y="3914640"/>
              <a:ext cx="23526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C01GT, ASAA04TC, AJTC02GT, ASAA01GA, AJCC02TA, ASCC02TA, AJAT01AC, AJTC02TA, AJAT02AA, AJAA01GT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6515280" y="42195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6772320" y="4114800"/>
              <a:ext cx="8380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TT02T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6505560" y="43815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6515280" y="46101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6781680" y="4495680"/>
              <a:ext cx="11430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4TG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6505560" y="526716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6181560" y="51814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47.8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6505560" y="5715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6743880" y="5619600"/>
              <a:ext cx="15238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SAT10AA, ASAG01GA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6181560" y="561024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64.5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6505560" y="59436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6743880" y="5829480"/>
              <a:ext cx="15238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2C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6505560" y="62197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6181560" y="6124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4.4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6724800" y="6086520"/>
              <a:ext cx="24382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AT01CT, ASGT02TA, AJGT03AG, ASAC01CT, ASTT05AA, AJTT06AA, AJTG01CT, ASTG02C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6515280" y="64008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6181560" y="62866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88.6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6734160" y="6286680"/>
              <a:ext cx="15238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T02AC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6181560" y="6445080"/>
              <a:ext cx="457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37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Times New Roman"/>
                </a:rPr>
                <a:t>93.0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6715080" y="6448320"/>
              <a:ext cx="24382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</a:rPr>
                <a:t>AJCC01CT, AJGT02AT, AJAG03AT, ASGT04AT, AJGA02AT</a:t>
              </a:r>
              <a:endParaRPr b="0" lang="en-US" sz="6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6T15:00:45Z</dcterms:created>
  <dc:creator>Axel</dc:creator>
  <dc:description/>
  <dc:language>en-US</dc:language>
  <cp:lastModifiedBy>susiej</cp:lastModifiedBy>
  <dcterms:modified xsi:type="dcterms:W3CDTF">2005-02-15T12:08:46Z</dcterms:modified>
  <cp:revision>19</cp:revision>
  <dc:subject/>
  <dc:title>PowerPoint Presentation</dc:title>
</cp:coreProperties>
</file>